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6244FF-49B8-478A-94FF-99924E04A639}" v="17" dt="2021-03-26T23:19:48.6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286244FF-49B8-478A-94FF-99924E04A639}"/>
    <pc:docChg chg="custSel addSld delSld modSld sldOrd">
      <pc:chgData name="Sarah Hill" userId="b774f213905f0ee8" providerId="LiveId" clId="{286244FF-49B8-478A-94FF-99924E04A639}" dt="2021-03-27T18:27:34.083" v="752" actId="20577"/>
      <pc:docMkLst>
        <pc:docMk/>
      </pc:docMkLst>
      <pc:sldChg chg="addSp delSp modSp mod">
        <pc:chgData name="Sarah Hill" userId="b774f213905f0ee8" providerId="LiveId" clId="{286244FF-49B8-478A-94FF-99924E04A639}" dt="2021-03-25T13:22:48.799" v="741" actId="1076"/>
        <pc:sldMkLst>
          <pc:docMk/>
          <pc:sldMk cId="2724142132" sldId="256"/>
        </pc:sldMkLst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2" creationId="{26A94E69-3C63-4696-9203-8C8091242B7A}"/>
          </ac:spMkLst>
        </pc:spChg>
        <pc:spChg chg="add del mod">
          <ac:chgData name="Sarah Hill" userId="b774f213905f0ee8" providerId="LiveId" clId="{286244FF-49B8-478A-94FF-99924E04A639}" dt="2021-03-25T12:12:48.046" v="153"/>
          <ac:spMkLst>
            <pc:docMk/>
            <pc:sldMk cId="2724142132" sldId="256"/>
            <ac:spMk id="3" creationId="{C0CD936A-97D6-48CB-BD3A-C6274753FBD5}"/>
          </ac:spMkLst>
        </pc:spChg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4" creationId="{CC5078C6-0DBB-465E-9DFC-5DFEE6C0C131}"/>
          </ac:spMkLst>
        </pc:spChg>
        <pc:spChg chg="add del mod">
          <ac:chgData name="Sarah Hill" userId="b774f213905f0ee8" providerId="LiveId" clId="{286244FF-49B8-478A-94FF-99924E04A639}" dt="2021-03-25T04:59:54.118" v="129" actId="478"/>
          <ac:spMkLst>
            <pc:docMk/>
            <pc:sldMk cId="2724142132" sldId="256"/>
            <ac:spMk id="6" creationId="{F8A31554-5F51-4A15-869F-6620DC6BB688}"/>
          </ac:spMkLst>
        </pc:spChg>
        <pc:spChg chg="add del mod">
          <ac:chgData name="Sarah Hill" userId="b774f213905f0ee8" providerId="LiveId" clId="{286244FF-49B8-478A-94FF-99924E04A639}" dt="2021-03-25T12:21:28.855" v="378" actId="478"/>
          <ac:spMkLst>
            <pc:docMk/>
            <pc:sldMk cId="2724142132" sldId="256"/>
            <ac:spMk id="7" creationId="{E6D710C2-D188-4CCF-A8DC-F1ABB5002F20}"/>
          </ac:spMkLst>
        </pc:spChg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8" creationId="{D793B1A7-025D-41FC-8CD2-F6EB1A26294E}"/>
          </ac:spMkLst>
        </pc:spChg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9" creationId="{B9ABBC0C-6D19-4E96-A5A6-3CEDFA982AD9}"/>
          </ac:spMkLst>
        </pc:spChg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10" creationId="{DD5029C1-4878-4799-A059-C5FE1AABAC47}"/>
          </ac:spMkLst>
        </pc:spChg>
        <pc:spChg chg="add mod">
          <ac:chgData name="Sarah Hill" userId="b774f213905f0ee8" providerId="LiveId" clId="{286244FF-49B8-478A-94FF-99924E04A639}" dt="2021-03-25T13:22:41.367" v="740" actId="1036"/>
          <ac:spMkLst>
            <pc:docMk/>
            <pc:sldMk cId="2724142132" sldId="256"/>
            <ac:spMk id="11" creationId="{B27A4689-0700-4775-B1EC-9483AD636BA5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2" creationId="{4ACD6F4F-1F10-46D7-A4AE-EF9021A99F0F}"/>
          </ac:spMkLst>
        </pc:spChg>
        <pc:spChg chg="add del mod">
          <ac:chgData name="Sarah Hill" userId="b774f213905f0ee8" providerId="LiveId" clId="{286244FF-49B8-478A-94FF-99924E04A639}" dt="2021-03-25T12:15:16.396" v="377" actId="478"/>
          <ac:spMkLst>
            <pc:docMk/>
            <pc:sldMk cId="2724142132" sldId="256"/>
            <ac:spMk id="13" creationId="{6CFF097E-5393-4CC7-A75F-4505BBA95E7E}"/>
          </ac:spMkLst>
        </pc:spChg>
        <pc:spChg chg="add del mod">
          <ac:chgData name="Sarah Hill" userId="b774f213905f0ee8" providerId="LiveId" clId="{286244FF-49B8-478A-94FF-99924E04A639}" dt="2021-03-25T12:21:29.750" v="379" actId="478"/>
          <ac:spMkLst>
            <pc:docMk/>
            <pc:sldMk cId="2724142132" sldId="256"/>
            <ac:spMk id="14" creationId="{5A31F91A-251C-4D36-9306-579B71567CDA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5" creationId="{3A665253-83B2-448A-B5FE-308C45342FF8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6" creationId="{C406223C-D0FE-422A-A26D-6C901E47F12A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7" creationId="{A98E6BD5-8C09-43DB-968A-0582044F31B9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8" creationId="{F51B732F-81B5-462C-A363-076BF243DF9A}"/>
          </ac:spMkLst>
        </pc:spChg>
        <pc:spChg chg="add mod">
          <ac:chgData name="Sarah Hill" userId="b774f213905f0ee8" providerId="LiveId" clId="{286244FF-49B8-478A-94FF-99924E04A639}" dt="2021-03-25T13:22:48.799" v="741" actId="1076"/>
          <ac:spMkLst>
            <pc:docMk/>
            <pc:sldMk cId="2724142132" sldId="256"/>
            <ac:spMk id="19" creationId="{001CA088-8C32-4154-A86E-0842884DD9CD}"/>
          </ac:spMkLst>
        </pc:spChg>
        <pc:picChg chg="add mod ord">
          <ac:chgData name="Sarah Hill" userId="b774f213905f0ee8" providerId="LiveId" clId="{286244FF-49B8-478A-94FF-99924E04A639}" dt="2021-03-25T13:22:31.979" v="735" actId="167"/>
          <ac:picMkLst>
            <pc:docMk/>
            <pc:sldMk cId="2724142132" sldId="256"/>
            <ac:picMk id="5" creationId="{2AE4ADC6-4455-4C5A-9B01-E951B11EE9D8}"/>
          </ac:picMkLst>
        </pc:picChg>
        <pc:picChg chg="add del mod">
          <ac:chgData name="Sarah Hill" userId="b774f213905f0ee8" providerId="LiveId" clId="{286244FF-49B8-478A-94FF-99924E04A639}" dt="2021-03-25T12:40:29.087" v="434" actId="478"/>
          <ac:picMkLst>
            <pc:docMk/>
            <pc:sldMk cId="2724142132" sldId="256"/>
            <ac:picMk id="5" creationId="{60931D64-0642-4A8F-9391-7766EE9E4C7A}"/>
          </ac:picMkLst>
        </pc:picChg>
        <pc:picChg chg="add del mod">
          <ac:chgData name="Sarah Hill" userId="b774f213905f0ee8" providerId="LiveId" clId="{286244FF-49B8-478A-94FF-99924E04A639}" dt="2021-03-25T13:20:24.533" v="727" actId="478"/>
          <ac:picMkLst>
            <pc:docMk/>
            <pc:sldMk cId="2724142132" sldId="256"/>
            <ac:picMk id="6" creationId="{3A40DE49-462C-48A2-B062-BE42ADD41ED1}"/>
          </ac:picMkLst>
        </pc:picChg>
      </pc:sldChg>
      <pc:sldChg chg="addSp delSp modSp new mod ord">
        <pc:chgData name="Sarah Hill" userId="b774f213905f0ee8" providerId="LiveId" clId="{286244FF-49B8-478A-94FF-99924E04A639}" dt="2021-03-27T18:27:34.083" v="752" actId="20577"/>
        <pc:sldMkLst>
          <pc:docMk/>
          <pc:sldMk cId="1081373503" sldId="257"/>
        </pc:sldMkLst>
        <pc:spChg chg="add del mod">
          <ac:chgData name="Sarah Hill" userId="b774f213905f0ee8" providerId="LiveId" clId="{286244FF-49B8-478A-94FF-99924E04A639}" dt="2021-03-25T12:24:51.857" v="380" actId="478"/>
          <ac:spMkLst>
            <pc:docMk/>
            <pc:sldMk cId="1081373503" sldId="257"/>
            <ac:spMk id="2" creationId="{1C27C29A-2405-449F-AA5F-D67B4EE9755F}"/>
          </ac:spMkLst>
        </pc:spChg>
        <pc:spChg chg="add mod">
          <ac:chgData name="Sarah Hill" userId="b774f213905f0ee8" providerId="LiveId" clId="{286244FF-49B8-478A-94FF-99924E04A639}" dt="2021-03-27T18:27:34.083" v="752" actId="20577"/>
          <ac:spMkLst>
            <pc:docMk/>
            <pc:sldMk cId="1081373503" sldId="257"/>
            <ac:spMk id="3" creationId="{EFECEF27-AEE0-4EBB-9096-BDF672D082F8}"/>
          </ac:spMkLst>
        </pc:spChg>
        <pc:spChg chg="add mod">
          <ac:chgData name="Sarah Hill" userId="b774f213905f0ee8" providerId="LiveId" clId="{286244FF-49B8-478A-94FF-99924E04A639}" dt="2021-03-26T23:19:48.638" v="742"/>
          <ac:spMkLst>
            <pc:docMk/>
            <pc:sldMk cId="1081373503" sldId="257"/>
            <ac:spMk id="4" creationId="{E770F62B-7724-46E4-8D06-B50E7392D24C}"/>
          </ac:spMkLst>
        </pc:spChg>
      </pc:sldChg>
      <pc:sldChg chg="addSp modSp new del mod">
        <pc:chgData name="Sarah Hill" userId="b774f213905f0ee8" providerId="LiveId" clId="{286244FF-49B8-478A-94FF-99924E04A639}" dt="2021-03-25T13:19:35.998" v="724" actId="2696"/>
        <pc:sldMkLst>
          <pc:docMk/>
          <pc:sldMk cId="2511602869" sldId="258"/>
        </pc:sldMkLst>
        <pc:spChg chg="add mod">
          <ac:chgData name="Sarah Hill" userId="b774f213905f0ee8" providerId="LiveId" clId="{286244FF-49B8-478A-94FF-99924E04A639}" dt="2021-03-25T12:58:11.639" v="585"/>
          <ac:spMkLst>
            <pc:docMk/>
            <pc:sldMk cId="2511602869" sldId="258"/>
            <ac:spMk id="2" creationId="{4B1BEC75-DA63-4647-9003-EF80485CBC3C}"/>
          </ac:spMkLst>
        </pc:spChg>
      </pc:sldChg>
      <pc:sldChg chg="addSp modSp new del mod">
        <pc:chgData name="Sarah Hill" userId="b774f213905f0ee8" providerId="LiveId" clId="{286244FF-49B8-478A-94FF-99924E04A639}" dt="2021-03-25T13:20:20.912" v="726" actId="2696"/>
        <pc:sldMkLst>
          <pc:docMk/>
          <pc:sldMk cId="223447925" sldId="259"/>
        </pc:sldMkLst>
        <pc:spChg chg="add mod">
          <ac:chgData name="Sarah Hill" userId="b774f213905f0ee8" providerId="LiveId" clId="{286244FF-49B8-478A-94FF-99924E04A639}" dt="2021-03-25T12:59:11.865" v="612" actId="20577"/>
          <ac:spMkLst>
            <pc:docMk/>
            <pc:sldMk cId="223447925" sldId="259"/>
            <ac:spMk id="4" creationId="{D2DC3610-C820-4B0F-8206-6559B01E64D2}"/>
          </ac:spMkLst>
        </pc:spChg>
        <pc:spChg chg="add mod">
          <ac:chgData name="Sarah Hill" userId="b774f213905f0ee8" providerId="LiveId" clId="{286244FF-49B8-478A-94FF-99924E04A639}" dt="2021-03-25T12:59:24.573" v="628" actId="20577"/>
          <ac:spMkLst>
            <pc:docMk/>
            <pc:sldMk cId="223447925" sldId="259"/>
            <ac:spMk id="5" creationId="{8FADF508-12CB-4F95-8D4D-297238FBEF90}"/>
          </ac:spMkLst>
        </pc:spChg>
        <pc:picChg chg="add mod modCrop">
          <ac:chgData name="Sarah Hill" userId="b774f213905f0ee8" providerId="LiveId" clId="{286244FF-49B8-478A-94FF-99924E04A639}" dt="2021-03-25T12:56:04.470" v="442" actId="732"/>
          <ac:picMkLst>
            <pc:docMk/>
            <pc:sldMk cId="223447925" sldId="259"/>
            <ac:picMk id="3" creationId="{3F00A8A4-2A2B-44E1-9FA7-E1996A4A8FA8}"/>
          </ac:picMkLst>
        </pc:picChg>
      </pc:sldChg>
      <pc:sldChg chg="new del">
        <pc:chgData name="Sarah Hill" userId="b774f213905f0ee8" providerId="LiveId" clId="{286244FF-49B8-478A-94FF-99924E04A639}" dt="2021-03-25T13:19:37.934" v="725" actId="2696"/>
        <pc:sldMkLst>
          <pc:docMk/>
          <pc:sldMk cId="890058059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77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1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55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270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655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49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4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91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65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48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551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832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FECEF27-AEE0-4EBB-9096-BDF672D082F8}"/>
              </a:ext>
            </a:extLst>
          </p:cNvPr>
          <p:cNvSpPr txBox="1"/>
          <p:nvPr/>
        </p:nvSpPr>
        <p:spPr>
          <a:xfrm>
            <a:off x="1090246" y="1981200"/>
            <a:ext cx="4794739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ane order for HEC1B vector and HEC1B p53DD in Figure 3H</a:t>
            </a:r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14-HEC1B+p53DD</a:t>
            </a:r>
          </a:p>
          <a:p>
            <a:r>
              <a:rPr lang="en-US" dirty="0"/>
              <a:t>13-HEC1B+pBABE vector</a:t>
            </a:r>
          </a:p>
          <a:p>
            <a:r>
              <a:rPr lang="en-US" dirty="0"/>
              <a:t>12-Ladder</a:t>
            </a:r>
          </a:p>
          <a:p>
            <a:r>
              <a:rPr lang="en-US" dirty="0"/>
              <a:t>11 Not this figure</a:t>
            </a:r>
          </a:p>
          <a:p>
            <a:r>
              <a:rPr lang="en-US" dirty="0"/>
              <a:t>10 Not this figure</a:t>
            </a:r>
          </a:p>
          <a:p>
            <a:r>
              <a:rPr lang="en-US" dirty="0"/>
              <a:t>9 Not this figure</a:t>
            </a:r>
          </a:p>
          <a:p>
            <a:r>
              <a:rPr lang="en-US" dirty="0"/>
              <a:t>8 Not this figure</a:t>
            </a:r>
          </a:p>
          <a:p>
            <a:r>
              <a:rPr lang="en-US" dirty="0"/>
              <a:t>7 Not this figure</a:t>
            </a:r>
          </a:p>
          <a:p>
            <a:r>
              <a:rPr lang="en-US" dirty="0"/>
              <a:t>6 Not this figure</a:t>
            </a:r>
          </a:p>
          <a:p>
            <a:r>
              <a:rPr lang="en-US" dirty="0"/>
              <a:t>5 Not this figure</a:t>
            </a:r>
          </a:p>
          <a:p>
            <a:r>
              <a:rPr lang="en-US" dirty="0"/>
              <a:t>4 Not this figure</a:t>
            </a:r>
          </a:p>
          <a:p>
            <a:r>
              <a:rPr lang="en-US" dirty="0"/>
              <a:t>3 Not this figure</a:t>
            </a:r>
          </a:p>
          <a:p>
            <a:r>
              <a:rPr lang="en-US" dirty="0"/>
              <a:t>2 Not this figure</a:t>
            </a:r>
          </a:p>
          <a:p>
            <a:r>
              <a:rPr lang="en-US" dirty="0"/>
              <a:t>1 Not this figur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770F62B-7724-46E4-8D06-B50E7392D24C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1081373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2AE4ADC6-4455-4C5A-9B01-E951B11EE9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0234"/>
            <a:ext cx="6858000" cy="8285299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C5078C6-0DBB-465E-9DFC-5DFEE6C0C131}"/>
              </a:ext>
            </a:extLst>
          </p:cNvPr>
          <p:cNvSpPr/>
          <p:nvPr/>
        </p:nvSpPr>
        <p:spPr>
          <a:xfrm>
            <a:off x="0" y="567126"/>
            <a:ext cx="3323493" cy="1078523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93B1A7-025D-41FC-8CD2-F6EB1A26294E}"/>
              </a:ext>
            </a:extLst>
          </p:cNvPr>
          <p:cNvSpPr txBox="1"/>
          <p:nvPr/>
        </p:nvSpPr>
        <p:spPr>
          <a:xfrm>
            <a:off x="0" y="187586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ABBC0C-6D19-4E96-A5A6-3CEDFA982AD9}"/>
              </a:ext>
            </a:extLst>
          </p:cNvPr>
          <p:cNvSpPr txBox="1"/>
          <p:nvPr/>
        </p:nvSpPr>
        <p:spPr>
          <a:xfrm>
            <a:off x="1746737" y="187587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5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6A94E69-3C63-4696-9203-8C8091242B7A}"/>
              </a:ext>
            </a:extLst>
          </p:cNvPr>
          <p:cNvSpPr txBox="1"/>
          <p:nvPr/>
        </p:nvSpPr>
        <p:spPr>
          <a:xfrm rot="16200000">
            <a:off x="894933" y="1613382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D5029C1-4878-4799-A059-C5FE1AABAC47}"/>
              </a:ext>
            </a:extLst>
          </p:cNvPr>
          <p:cNvSpPr txBox="1"/>
          <p:nvPr/>
        </p:nvSpPr>
        <p:spPr>
          <a:xfrm rot="16200000">
            <a:off x="2227385" y="1847115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27A4689-0700-4775-B1EC-9483AD636BA5}"/>
              </a:ext>
            </a:extLst>
          </p:cNvPr>
          <p:cNvSpPr txBox="1"/>
          <p:nvPr/>
        </p:nvSpPr>
        <p:spPr>
          <a:xfrm rot="16200000">
            <a:off x="2378386" y="1023914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-13- 14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ACD6F4F-1F10-46D7-A4AE-EF9021A99F0F}"/>
              </a:ext>
            </a:extLst>
          </p:cNvPr>
          <p:cNvSpPr/>
          <p:nvPr/>
        </p:nvSpPr>
        <p:spPr>
          <a:xfrm>
            <a:off x="164123" y="5052650"/>
            <a:ext cx="3475893" cy="1078523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665253-83B2-448A-B5FE-308C45342FF8}"/>
              </a:ext>
            </a:extLst>
          </p:cNvPr>
          <p:cNvSpPr txBox="1"/>
          <p:nvPr/>
        </p:nvSpPr>
        <p:spPr>
          <a:xfrm>
            <a:off x="164124" y="4673109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06223C-D0FE-422A-A26D-6C901E47F12A}"/>
              </a:ext>
            </a:extLst>
          </p:cNvPr>
          <p:cNvSpPr txBox="1"/>
          <p:nvPr/>
        </p:nvSpPr>
        <p:spPr>
          <a:xfrm>
            <a:off x="1910861" y="4673110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5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98E6BD5-8C09-43DB-968A-0582044F31B9}"/>
              </a:ext>
            </a:extLst>
          </p:cNvPr>
          <p:cNvSpPr txBox="1"/>
          <p:nvPr/>
        </p:nvSpPr>
        <p:spPr>
          <a:xfrm rot="16200000">
            <a:off x="1059057" y="6098905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51B732F-81B5-462C-A363-076BF243DF9A}"/>
              </a:ext>
            </a:extLst>
          </p:cNvPr>
          <p:cNvSpPr txBox="1"/>
          <p:nvPr/>
        </p:nvSpPr>
        <p:spPr>
          <a:xfrm rot="16200000">
            <a:off x="2391509" y="6332638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1CA088-8C32-4154-A86E-0842884DD9CD}"/>
              </a:ext>
            </a:extLst>
          </p:cNvPr>
          <p:cNvSpPr txBox="1"/>
          <p:nvPr/>
        </p:nvSpPr>
        <p:spPr>
          <a:xfrm rot="16200000">
            <a:off x="2542510" y="5509437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-13- 14</a:t>
            </a:r>
          </a:p>
        </p:txBody>
      </p:sp>
    </p:spTree>
    <p:extLst>
      <p:ext uri="{BB962C8B-B14F-4D97-AF65-F5344CB8AC3E}">
        <p14:creationId xmlns:p14="http://schemas.microsoft.com/office/powerpoint/2010/main" val="2724142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3</Words>
  <Application>Microsoft Office PowerPoint</Application>
  <PresentationFormat>Letter Paper (8.5x11 in)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Hill</dc:creator>
  <cp:lastModifiedBy>Sarah Hill</cp:lastModifiedBy>
  <cp:revision>1</cp:revision>
  <dcterms:created xsi:type="dcterms:W3CDTF">2021-03-25T04:32:01Z</dcterms:created>
  <dcterms:modified xsi:type="dcterms:W3CDTF">2021-03-27T18:27:46Z</dcterms:modified>
</cp:coreProperties>
</file>